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9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A87F6-7B68-4BF6-95AC-3B613D863A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09D29-C458-4195-8888-119214F78A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CF9C4-29F9-490C-8C33-C2AA5E10BE7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F0EB9-1047-47D6-A541-3FB9D9E0EA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AC9CBA-E7F1-4515-B5A2-70A569B1D2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44526C-E98E-4B55-B1BA-FA46FFC36A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CDDF7-C702-4243-A51B-FE1431EBFE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16766-5F5E-4D3C-A6AC-C3E4E6EA29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ABF7B-A74A-45B9-8735-E1E9F8D2BE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C8EC2-8F44-432E-A9E9-5E9446C38E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7AE7A-4AC1-40ED-B78F-A43A195B9E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6F017-0DD2-45F5-807A-6B355359C3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C749F0-EDA9-4D1D-95CA-EB09310F31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Relationship Id="rId1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87400" y="685800"/>
            <a:ext cx="4750560" cy="7680240"/>
            <a:chOff x="887400" y="685800"/>
            <a:chExt cx="4750560" cy="7680240"/>
          </a:xfrm>
        </p:grpSpPr>
        <p:graphicFrame>
          <p:nvGraphicFramePr>
            <p:cNvPr id="42" name=""/>
            <p:cNvGraphicFramePr/>
            <p:nvPr/>
          </p:nvGraphicFramePr>
          <p:xfrm>
            <a:off x="1305000" y="873000"/>
            <a:ext cx="2494080" cy="19465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305000" y="873000"/>
                      <a:ext cx="2494080" cy="1946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4" name=""/>
            <p:cNvSpPr/>
            <p:nvPr/>
          </p:nvSpPr>
          <p:spPr>
            <a:xfrm>
              <a:off x="1609920" y="2852640"/>
              <a:ext cx="1981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409840" y="2743200"/>
              <a:ext cx="45720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CR</a:t>
              </a:r>
              <a:r>
                <a:rPr b="1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887400" y="1158840"/>
              <a:ext cx="406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887400" y="2225520"/>
              <a:ext cx="54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BALB/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782720" y="70164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lo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078000" y="701640"/>
              <a:ext cx="43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CD4</a:t>
              </a:r>
              <a:r>
                <a:rPr b="1" lang="en-US" sz="800" spc="-1" strike="noStrike" baseline="30000">
                  <a:solidFill>
                    <a:srgbClr val="000000"/>
                  </a:solidFill>
                  <a:latin typeface="Arial"/>
                </a:rPr>
                <a:t>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703880" y="968400"/>
              <a:ext cx="50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80% / 2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939040" y="96840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29% / 70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618200" y="1978200"/>
              <a:ext cx="50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52% / 7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862720" y="197820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0% / 88%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911160" y="685800"/>
              <a:ext cx="2971800" cy="2362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948240" y="74448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6" name=""/>
            <p:cNvGrpSpPr/>
            <p:nvPr/>
          </p:nvGrpSpPr>
          <p:grpSpPr>
            <a:xfrm>
              <a:off x="898200" y="3146400"/>
              <a:ext cx="4739760" cy="5219640"/>
              <a:chOff x="898200" y="3146400"/>
              <a:chExt cx="4739760" cy="5219640"/>
            </a:xfrm>
          </p:grpSpPr>
          <p:sp>
            <p:nvSpPr>
              <p:cNvPr id="57" name=""/>
              <p:cNvSpPr/>
              <p:nvPr/>
            </p:nvSpPr>
            <p:spPr>
              <a:xfrm rot="16200000">
                <a:off x="1237320" y="34758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138456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51776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66068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79064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892160" y="3500280"/>
                <a:ext cx="287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.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06388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19096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32740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457360" y="350028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571480" y="3500280"/>
                <a:ext cx="27504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/</a:t>
                </a:r>
                <a:r>
                  <a:rPr b="0" lang="en-US" sz="6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71152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84508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96892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310212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322596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35952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49596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63240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3749760" y="350028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973800" y="3446640"/>
                <a:ext cx="36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(b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3944880" y="373212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3944880" y="4227480"/>
                <a:ext cx="48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0" name="" descr=""/>
              <p:cNvPicPr/>
              <p:nvPr/>
            </p:nvPicPr>
            <p:blipFill>
              <a:blip r:embed="rId3"/>
              <a:srcRect l="25785" t="41890" r="27826" b="48087"/>
              <a:stretch/>
            </p:blipFill>
            <p:spPr>
              <a:xfrm>
                <a:off x="1247760" y="4143240"/>
                <a:ext cx="2743200" cy="343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1" name=""/>
              <p:cNvSpPr/>
              <p:nvPr/>
            </p:nvSpPr>
            <p:spPr>
              <a:xfrm>
                <a:off x="1185840" y="41702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185840" y="42656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185840" y="43671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902880" y="40640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902880" y="41576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902880" y="426708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7" name="" descr=""/>
              <p:cNvPicPr/>
              <p:nvPr/>
            </p:nvPicPr>
            <p:blipFill>
              <a:blip r:embed="rId4"/>
              <a:srcRect l="20975" t="46219" r="33410" b="43560"/>
              <a:stretch/>
            </p:blipFill>
            <p:spPr>
              <a:xfrm>
                <a:off x="1247760" y="3648240"/>
                <a:ext cx="2743200" cy="38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" name=""/>
              <p:cNvSpPr/>
              <p:nvPr/>
            </p:nvSpPr>
            <p:spPr>
              <a:xfrm>
                <a:off x="1181160" y="36720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181160" y="37828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1181160" y="38926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898200" y="35654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898200" y="36752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898200" y="37861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4" name=""/>
              <p:cNvGrpSpPr/>
              <p:nvPr/>
            </p:nvGrpSpPr>
            <p:grpSpPr>
              <a:xfrm>
                <a:off x="4329000" y="3790800"/>
                <a:ext cx="76320" cy="609480"/>
                <a:chOff x="4329000" y="3790800"/>
                <a:chExt cx="76320" cy="609480"/>
              </a:xfrm>
            </p:grpSpPr>
            <p:sp>
              <p:nvSpPr>
                <p:cNvPr id="95" name=""/>
                <p:cNvSpPr/>
                <p:nvPr/>
              </p:nvSpPr>
              <p:spPr>
                <a:xfrm>
                  <a:off x="4405320" y="3790800"/>
                  <a:ext cx="0" cy="6094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4329000" y="379080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4329000" y="4400280"/>
                  <a:ext cx="76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8" name=""/>
              <p:cNvSpPr/>
              <p:nvPr/>
            </p:nvSpPr>
            <p:spPr>
              <a:xfrm>
                <a:off x="4435200" y="396072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l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 rot="16200000">
                <a:off x="1237320" y="45964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38456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51776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166068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79064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892160" y="4621320"/>
                <a:ext cx="287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.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06388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19096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32740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457360" y="462132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571480" y="4621320"/>
                <a:ext cx="27504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 baseline="30000">
                    <a:solidFill>
                      <a:srgbClr val="000000"/>
                    </a:solidFill>
                    <a:latin typeface="Arial"/>
                  </a:rPr>
                  <a:t>9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/</a:t>
                </a:r>
                <a:r>
                  <a:rPr b="0" lang="en-US" sz="600" spc="-1" strike="noStrike" baseline="-25000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71152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84508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96892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310212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322596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335952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349596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63240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749760" y="462132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973800" y="4567320"/>
                <a:ext cx="36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(b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3944880" y="485316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3944880" y="5348160"/>
                <a:ext cx="48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2" name=""/>
              <p:cNvGrpSpPr/>
              <p:nvPr/>
            </p:nvGrpSpPr>
            <p:grpSpPr>
              <a:xfrm>
                <a:off x="4334040" y="4902120"/>
                <a:ext cx="75960" cy="609480"/>
                <a:chOff x="4334040" y="4902120"/>
                <a:chExt cx="75960" cy="609480"/>
              </a:xfrm>
            </p:grpSpPr>
            <p:sp>
              <p:nvSpPr>
                <p:cNvPr id="123" name=""/>
                <p:cNvSpPr/>
                <p:nvPr/>
              </p:nvSpPr>
              <p:spPr>
                <a:xfrm>
                  <a:off x="4410000" y="4902120"/>
                  <a:ext cx="0" cy="6094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4334040" y="4902120"/>
                  <a:ext cx="75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4334040" y="5511600"/>
                  <a:ext cx="75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6" name=""/>
              <p:cNvSpPr/>
              <p:nvPr/>
            </p:nvSpPr>
            <p:spPr>
              <a:xfrm>
                <a:off x="4440240" y="507204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h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27" name="" descr=""/>
              <p:cNvPicPr/>
              <p:nvPr/>
            </p:nvPicPr>
            <p:blipFill>
              <a:blip r:embed="rId5"/>
              <a:srcRect l="27206" t="36079" r="27179" b="55685"/>
              <a:stretch/>
            </p:blipFill>
            <p:spPr>
              <a:xfrm>
                <a:off x="1262160" y="4768920"/>
                <a:ext cx="2719440" cy="380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8" name="" descr=""/>
              <p:cNvPicPr/>
              <p:nvPr/>
            </p:nvPicPr>
            <p:blipFill>
              <a:blip r:embed="rId6"/>
              <a:srcRect l="27987" t="34812" r="22255" b="53790"/>
              <a:stretch/>
            </p:blipFill>
            <p:spPr>
              <a:xfrm>
                <a:off x="1262160" y="5245200"/>
                <a:ext cx="2719440" cy="38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29" name=""/>
              <p:cNvSpPr/>
              <p:nvPr/>
            </p:nvSpPr>
            <p:spPr>
              <a:xfrm>
                <a:off x="1185840" y="52912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1185840" y="53863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1185840" y="54878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902880" y="51847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902880" y="52783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902880" y="53881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1181160" y="47926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1181160" y="49039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1181160" y="50133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898200" y="468648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898200" y="47959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898200" y="490680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41" name="" descr=""/>
              <p:cNvPicPr/>
              <p:nvPr/>
            </p:nvPicPr>
            <p:blipFill>
              <a:blip r:embed="rId7"/>
              <a:srcRect l="26054" t="44629" r="24384" b="46255"/>
              <a:stretch/>
            </p:blipFill>
            <p:spPr>
              <a:xfrm>
                <a:off x="1262160" y="6048360"/>
                <a:ext cx="2909880" cy="38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42" name=""/>
              <p:cNvSpPr/>
              <p:nvPr/>
            </p:nvSpPr>
            <p:spPr>
              <a:xfrm rot="16200000">
                <a:off x="1184760" y="587592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133200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46520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60812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73844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86840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199548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213192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226224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249408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264492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277848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290232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03552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315936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29256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42936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55140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67380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973800" y="5846760"/>
                <a:ext cx="36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(b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140000" y="613260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140360" y="6627960"/>
                <a:ext cx="48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1181160" y="60627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1181160" y="61596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1181160" y="62532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898200" y="595620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898200" y="605160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898200" y="61531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70" name=""/>
              <p:cNvGrpSpPr/>
              <p:nvPr/>
            </p:nvGrpSpPr>
            <p:grpSpPr>
              <a:xfrm>
                <a:off x="4524480" y="6191280"/>
                <a:ext cx="75960" cy="609480"/>
                <a:chOff x="4524480" y="6191280"/>
                <a:chExt cx="75960" cy="609480"/>
              </a:xfrm>
            </p:grpSpPr>
            <p:sp>
              <p:nvSpPr>
                <p:cNvPr id="171" name=""/>
                <p:cNvSpPr/>
                <p:nvPr/>
              </p:nvSpPr>
              <p:spPr>
                <a:xfrm>
                  <a:off x="4600440" y="6191280"/>
                  <a:ext cx="0" cy="6094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4524480" y="6191280"/>
                  <a:ext cx="75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4524480" y="6800760"/>
                  <a:ext cx="75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4" name=""/>
              <p:cNvSpPr/>
              <p:nvPr/>
            </p:nvSpPr>
            <p:spPr>
              <a:xfrm>
                <a:off x="4630680" y="636120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lo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75" name="" descr=""/>
              <p:cNvPicPr/>
              <p:nvPr/>
            </p:nvPicPr>
            <p:blipFill>
              <a:blip r:embed="rId8"/>
              <a:srcRect l="24357" t="38620" r="25751" b="51886"/>
              <a:stretch/>
            </p:blipFill>
            <p:spPr>
              <a:xfrm>
                <a:off x="1266840" y="6562800"/>
                <a:ext cx="2909880" cy="38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6" name=""/>
              <p:cNvSpPr/>
              <p:nvPr/>
            </p:nvSpPr>
            <p:spPr>
              <a:xfrm>
                <a:off x="2392560" y="590076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803760" y="590076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 rot="16200000">
                <a:off x="3824640" y="5772600"/>
                <a:ext cx="480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on.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1181160" y="63453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898200" y="62341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1181160" y="65768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1181160" y="66736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1181160" y="67676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898200" y="64706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898200" y="65660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898200" y="666756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181160" y="68594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898200" y="674856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 rot="16200000">
                <a:off x="3840840" y="7096680"/>
                <a:ext cx="480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Con.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rot="16200000">
                <a:off x="1184760" y="72000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td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33200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146520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160812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73844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86840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99548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213192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226224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249408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264492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77848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290232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303552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315936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329256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342936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355140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367380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1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973800" y="7170840"/>
                <a:ext cx="36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(bp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140000" y="7456320"/>
                <a:ext cx="40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NOD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4140360" y="7951680"/>
                <a:ext cx="487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Balb/c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1181160" y="73864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181160" y="74833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1181160" y="75772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898200" y="728028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898200" y="737568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898200" y="747720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4600440" y="7515360"/>
                <a:ext cx="0" cy="609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4524480" y="751536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4524480" y="8124840"/>
                <a:ext cx="75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4630680" y="7684920"/>
                <a:ext cx="43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CD4</a:t>
                </a:r>
                <a:r>
                  <a:rPr b="1" lang="en-US" sz="800" spc="-1" strike="noStrike" baseline="30000">
                    <a:solidFill>
                      <a:srgbClr val="000000"/>
                    </a:solidFill>
                    <a:latin typeface="Arial"/>
                  </a:rPr>
                  <a:t>hi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2392560" y="7224840"/>
                <a:ext cx="223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9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3803760" y="7224840"/>
                <a:ext cx="266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181160" y="76834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898200" y="75722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181160" y="79009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181160" y="79977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1181160" y="80913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898200" y="779472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7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898200" y="788976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898200" y="799164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1181160" y="82026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898200" y="809136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34" name="" descr=""/>
              <p:cNvPicPr/>
              <p:nvPr/>
            </p:nvPicPr>
            <p:blipFill>
              <a:blip r:embed="rId9"/>
              <a:srcRect l="28513" t="34220" r="21595" b="58182"/>
              <a:stretch/>
            </p:blipFill>
            <p:spPr>
              <a:xfrm>
                <a:off x="1266840" y="7372440"/>
                <a:ext cx="2905200" cy="352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5" name="" descr=""/>
              <p:cNvPicPr/>
              <p:nvPr/>
            </p:nvPicPr>
            <p:blipFill>
              <a:blip r:embed="rId10"/>
              <a:srcRect l="21507" t="32917" r="24323" b="57589"/>
              <a:stretch/>
            </p:blipFill>
            <p:spPr>
              <a:xfrm>
                <a:off x="1257480" y="7877160"/>
                <a:ext cx="2895480" cy="380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36" name=""/>
              <p:cNvSpPr/>
              <p:nvPr/>
            </p:nvSpPr>
            <p:spPr>
              <a:xfrm>
                <a:off x="5054760" y="6137280"/>
                <a:ext cx="0" cy="205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978440" y="61372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4978440" y="819792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5054760" y="3606840"/>
                <a:ext cx="0" cy="2057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978440" y="36068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978440" y="566424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5086800" y="4556160"/>
                <a:ext cx="551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TCR V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5086800" y="7075440"/>
                <a:ext cx="543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</a:rPr>
                  <a:t>TCR V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911160" y="3146400"/>
                <a:ext cx="4724640" cy="521964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964080" y="3200400"/>
                <a:ext cx="272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3T19:40:57Z</dcterms:created>
  <dc:creator>Gisela Vaitaitis</dc:creator>
  <dc:description/>
  <dc:language>en-US</dc:language>
  <cp:lastModifiedBy>Gisela Vaitaitis</cp:lastModifiedBy>
  <dcterms:modified xsi:type="dcterms:W3CDTF">2008-03-13T19:41:30Z</dcterms:modified>
  <cp:revision>1</cp:revision>
  <dc:subject/>
  <dc:title>Slide 1</dc:title>
</cp:coreProperties>
</file>